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69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Prep%20for%20resubmission\Third_sod1paraquat50u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Prep%20for%20resubmission\Third_sod1paraquat50u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17329330076706"/>
          <c:y val="0.27761634753725045"/>
          <c:w val="0.7540857392825896"/>
          <c:h val="0.614984324876057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D!$H$65</c:f>
              <c:strCache>
                <c:ptCount val="1"/>
                <c:pt idx="0">
                  <c:v>No PQ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ND!$I$64:$J$64</c:f>
              <c:strCache>
                <c:ptCount val="2"/>
                <c:pt idx="0">
                  <c:v>WT</c:v>
                </c:pt>
                <c:pt idx="1">
                  <c:v>sod1</c:v>
                </c:pt>
              </c:strCache>
            </c:strRef>
          </c:cat>
          <c:val>
            <c:numRef>
              <c:f>ND!$I$65:$J$65</c:f>
              <c:numCache>
                <c:formatCode>0</c:formatCode>
                <c:ptCount val="2"/>
                <c:pt idx="0">
                  <c:v>188.74890071742652</c:v>
                </c:pt>
                <c:pt idx="1">
                  <c:v>263.934670233521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80-4E52-B546-2DCF1EE786C7}"/>
            </c:ext>
          </c:extLst>
        </c:ser>
        <c:ser>
          <c:idx val="1"/>
          <c:order val="1"/>
          <c:tx>
            <c:strRef>
              <c:f>ND!$H$66</c:f>
              <c:strCache>
                <c:ptCount val="1"/>
                <c:pt idx="0">
                  <c:v>50 uM PQ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ND!$I$64:$J$64</c:f>
              <c:strCache>
                <c:ptCount val="2"/>
                <c:pt idx="0">
                  <c:v>WT</c:v>
                </c:pt>
                <c:pt idx="1">
                  <c:v>sod1</c:v>
                </c:pt>
              </c:strCache>
            </c:strRef>
          </c:cat>
          <c:val>
            <c:numRef>
              <c:f>ND!$I$66:$J$66</c:f>
              <c:numCache>
                <c:formatCode>0</c:formatCode>
                <c:ptCount val="2"/>
                <c:pt idx="0">
                  <c:v>197.18462931815242</c:v>
                </c:pt>
                <c:pt idx="1">
                  <c:v>565.00933706816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80-4E52-B546-2DCF1EE786C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25"/>
        <c:axId val="357446664"/>
        <c:axId val="357446992"/>
      </c:barChart>
      <c:catAx>
        <c:axId val="357446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446992"/>
        <c:crosses val="autoZero"/>
        <c:auto val="1"/>
        <c:lblAlgn val="ctr"/>
        <c:lblOffset val="100"/>
        <c:noMultiLvlLbl val="0"/>
      </c:catAx>
      <c:valAx>
        <c:axId val="357446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>
                    <a:solidFill>
                      <a:schemeClr val="tx1"/>
                    </a:solidFill>
                  </a:rPr>
                  <a:t>Median frequency</a:t>
                </a:r>
                <a:r>
                  <a:rPr lang="en-US" sz="1400" baseline="0" dirty="0">
                    <a:solidFill>
                      <a:schemeClr val="tx1"/>
                    </a:solidFill>
                  </a:rPr>
                  <a:t> Can R x10 </a:t>
                </a:r>
                <a:r>
                  <a:rPr lang="en-US" sz="1400" baseline="30000" dirty="0">
                    <a:solidFill>
                      <a:schemeClr val="tx1"/>
                    </a:solidFill>
                  </a:rPr>
                  <a:t>6</a:t>
                </a:r>
              </a:p>
            </c:rich>
          </c:tx>
          <c:layout>
            <c:manualLayout>
              <c:xMode val="edge"/>
              <c:yMode val="edge"/>
              <c:x val="8.7109436756217198E-2"/>
              <c:y val="0.255904032810473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446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14051778978083"/>
          <c:y val="0.20992777754800521"/>
          <c:w val="0.7540857392825896"/>
          <c:h val="0.614984324876057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D!$U$65</c:f>
              <c:strCache>
                <c:ptCount val="1"/>
                <c:pt idx="0">
                  <c:v>No PQ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40000"/>
                  <a:lumOff val="60000"/>
                </a:schemeClr>
              </a:solidFill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ND!$V$64:$W$64</c:f>
              <c:strCache>
                <c:ptCount val="2"/>
                <c:pt idx="0">
                  <c:v>WT</c:v>
                </c:pt>
                <c:pt idx="1">
                  <c:v>sod1</c:v>
                </c:pt>
              </c:strCache>
            </c:strRef>
          </c:cat>
          <c:val>
            <c:numRef>
              <c:f>ND!$V$65:$W$65</c:f>
              <c:numCache>
                <c:formatCode>0</c:formatCode>
                <c:ptCount val="2"/>
                <c:pt idx="0">
                  <c:v>11.873192557428929</c:v>
                </c:pt>
                <c:pt idx="1">
                  <c:v>3.33889816360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CB-44AC-A5EA-207BDA12D4D2}"/>
            </c:ext>
          </c:extLst>
        </c:ser>
        <c:ser>
          <c:idx val="1"/>
          <c:order val="1"/>
          <c:tx>
            <c:strRef>
              <c:f>ND!$U$66</c:f>
              <c:strCache>
                <c:ptCount val="1"/>
                <c:pt idx="0">
                  <c:v>50 uM PQ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ND!$V$64:$W$64</c:f>
              <c:strCache>
                <c:ptCount val="2"/>
                <c:pt idx="0">
                  <c:v>WT</c:v>
                </c:pt>
                <c:pt idx="1">
                  <c:v>sod1</c:v>
                </c:pt>
              </c:strCache>
            </c:strRef>
          </c:cat>
          <c:val>
            <c:numRef>
              <c:f>ND!$V$66:$W$66</c:f>
              <c:numCache>
                <c:formatCode>0</c:formatCode>
                <c:ptCount val="2"/>
                <c:pt idx="0">
                  <c:v>13.222926639927545</c:v>
                </c:pt>
                <c:pt idx="1">
                  <c:v>23.498964803312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CB-44AC-A5EA-207BDA12D4D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25"/>
        <c:axId val="357446664"/>
        <c:axId val="357446992"/>
      </c:barChart>
      <c:catAx>
        <c:axId val="357446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446992"/>
        <c:crosses val="autoZero"/>
        <c:auto val="1"/>
        <c:lblAlgn val="ctr"/>
        <c:lblOffset val="100"/>
        <c:noMultiLvlLbl val="0"/>
      </c:catAx>
      <c:valAx>
        <c:axId val="357446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>
                    <a:solidFill>
                      <a:schemeClr val="tx1"/>
                    </a:solidFill>
                  </a:rPr>
                  <a:t>Median frequency</a:t>
                </a:r>
                <a:r>
                  <a:rPr lang="en-US" sz="1400" baseline="0" dirty="0">
                    <a:solidFill>
                      <a:schemeClr val="tx1"/>
                    </a:solidFill>
                  </a:rPr>
                  <a:t> </a:t>
                </a:r>
                <a:r>
                  <a:rPr lang="en-US" sz="1400" baseline="0" dirty="0" err="1">
                    <a:solidFill>
                      <a:schemeClr val="tx1"/>
                    </a:solidFill>
                  </a:rPr>
                  <a:t>CanR</a:t>
                </a:r>
                <a:r>
                  <a:rPr lang="en-US" sz="1400" baseline="0" dirty="0">
                    <a:solidFill>
                      <a:schemeClr val="tx1"/>
                    </a:solidFill>
                  </a:rPr>
                  <a:t> Red x 10 </a:t>
                </a:r>
                <a:r>
                  <a:rPr lang="en-US" sz="1400" baseline="30000" dirty="0">
                    <a:solidFill>
                      <a:schemeClr val="tx1"/>
                    </a:solidFill>
                  </a:rPr>
                  <a:t>7</a:t>
                </a:r>
              </a:p>
            </c:rich>
          </c:tx>
          <c:layout>
            <c:manualLayout>
              <c:xMode val="edge"/>
              <c:yMode val="edge"/>
              <c:x val="8.4592860848397775E-2"/>
              <c:y val="0.154281864830353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446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DBD530-4A89-4FBF-B105-042D9D5C19AE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7F3134-570E-4125-8448-4C2A0901DD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24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:\Users\degtyarevanp\Desktop\ssMutpaperNIEHS\Prep for resubmission\Third_sod1paraquat50uM.xlsx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7F3134-570E-4125-8448-4C2A0901DDB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8854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00DE59-CD03-411B-870C-2D89DB846F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26ED54-548F-4224-B3DD-A4F78607EF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D9B0B-BDE7-4A77-8C1B-4C8A674C8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F04B9F-F761-4C41-ADF3-CD3C53E53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F1DB3C-492E-469E-B87A-05399A2EA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944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592D6-EA04-4E56-9180-4324A8593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6DADF2-FF37-4ABB-9D1C-6E58303233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E8788-D79F-42FB-BDA4-46A5FE6E7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8D3F5-DFAD-49BD-85B7-A51B5A168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DB4498-D1F4-4668-A126-C23E9D729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551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199382-52D5-4041-8CDE-703F0BB740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ABFE5C-B76A-472A-A63E-34A21485F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EE7EFE-1C72-47E5-B463-FB9CE9849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3A9AA-B8FF-48F4-BEA4-90E391701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C562A6-2BFD-4AE5-8DD7-762B4C454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8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561426-B65B-4A97-9FCF-29340C2B8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4DEC79-A3F0-421D-9093-41E93A45A7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5C23E0-2C3F-425D-9EE7-A36D1D93B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15E8D4-5841-46A1-908E-6C716BC44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847FDF-35CC-4EE0-95AA-83EA2038D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991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0ABA0-B565-4E35-AC2D-8553D7CF9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FFD575-0726-4FFF-B993-0E19E6124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E0524-C5B8-4C4B-ADEE-580C60B10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F9F9E8-DB0C-4BDD-A502-17850A4ED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ADE720-DB68-47D8-8DE4-89D20EE28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385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21A4B-5C69-4915-8986-AA6850979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1DB16E-790C-4DD8-AB86-355C987C6A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B64FFA-4FB7-47ED-BCCE-DD0921169C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291B86-5792-46B1-B069-C02BD8FC1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5466BB-C71B-4847-A682-168247C25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9F4EB1-DD25-48EA-A2A2-4A5D18680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02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D0B0E-0087-4A0E-918C-27B178A994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1A691A-9240-45FA-A78B-38E44C6AA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1FD8CD-E31F-424D-B905-F261A34347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FC9CAB-42D4-4185-96CE-36F5CF51DB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90962A-D23C-4C5F-94E1-CA0623C58E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B8C5C6-A857-42EC-9EBB-D369AF610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6779AB-5853-4F9D-BBAB-11A52120A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0366F4-DDB8-4C04-A269-742E4D62D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54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A0B9EA-A5E6-4F27-848B-2B7F468A0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C43AF4-B4EE-4457-8C1F-B37BC51F4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6AC822-3285-4E2A-86DD-0E5511035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7A810C-CCB5-4710-B1B3-40D74C7F6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642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BBF537A-4138-4652-ACFE-652202689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F93D22-D53D-48AD-B88F-0EB467004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823332-DB6E-43E7-B243-121B30776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05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278B3-4497-43BB-BFBF-D193165D0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1F6101-03E8-49BE-AF6E-E64844FC5C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5DFBE0-1468-4CD4-ACA1-22B540E58A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548D67-8D96-4722-8652-D8E356BE0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EFE7AD-8CCC-4B0F-A068-D393C61B1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66A4AD-2EF4-4D4F-BBD6-96D1C0901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281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2559EA-8872-4549-B95F-0AF3DE676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F793EF-739F-4DD9-A100-E6BB6ECE47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400344-1CA7-480D-AD02-DD3C6B2D5B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CFB05B-8844-4807-84EE-75FB8FF5E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3AC5D8-CEEA-40D5-8513-1180FA2EE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077E88-3753-47F6-B11F-39C564B27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94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868585-05B2-420F-B68D-107BB9A64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B0F13A-4425-4446-9D00-93C8CBA771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F871DF-326E-4CDC-8C65-117FA3F6C0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0D19E-5803-4659-BC50-B6E493DFF51D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528B1-FFF7-442F-A1BA-610FF4F211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144AB-0589-4506-90E4-A46C8078E9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CE5B8-A078-4F10-B998-A28F7AB94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312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E033AEF-526B-422C-83F6-4000A36CFF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6520217"/>
              </p:ext>
            </p:extLst>
          </p:nvPr>
        </p:nvGraphicFramePr>
        <p:xfrm>
          <a:off x="-309798" y="1107789"/>
          <a:ext cx="6369551" cy="4642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1CF5F7D-5BD3-4BD2-B5BD-12AC543915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7788969"/>
              </p:ext>
            </p:extLst>
          </p:nvPr>
        </p:nvGraphicFramePr>
        <p:xfrm>
          <a:off x="5536277" y="1443803"/>
          <a:ext cx="6816048" cy="4618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0" name="Group 9">
            <a:extLst>
              <a:ext uri="{FF2B5EF4-FFF2-40B4-BE49-F238E27FC236}">
                <a16:creationId xmlns:a16="http://schemas.microsoft.com/office/drawing/2014/main" id="{D364475D-5A9C-4A74-8137-271533636562}"/>
              </a:ext>
            </a:extLst>
          </p:cNvPr>
          <p:cNvGrpSpPr/>
          <p:nvPr/>
        </p:nvGrpSpPr>
        <p:grpSpPr>
          <a:xfrm>
            <a:off x="7740156" y="2346409"/>
            <a:ext cx="2452355" cy="321875"/>
            <a:chOff x="1920904" y="482797"/>
            <a:chExt cx="792148" cy="307777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89468A5-3A32-4827-AA4B-555C5E4EE4C6}"/>
                </a:ext>
              </a:extLst>
            </p:cNvPr>
            <p:cNvCxnSpPr>
              <a:cxnSpLocks/>
            </p:cNvCxnSpPr>
            <p:nvPr/>
          </p:nvCxnSpPr>
          <p:spPr>
            <a:xfrm>
              <a:off x="1920904" y="790574"/>
              <a:ext cx="7921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17C9BF0-D712-493E-B5FC-DDB3A53D76CA}"/>
                </a:ext>
              </a:extLst>
            </p:cNvPr>
            <p:cNvSpPr txBox="1"/>
            <p:nvPr/>
          </p:nvSpPr>
          <p:spPr>
            <a:xfrm>
              <a:off x="2260487" y="482797"/>
              <a:ext cx="112983" cy="2942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s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8056516-6E15-4D10-8260-DEB9A7435AC8}"/>
              </a:ext>
            </a:extLst>
          </p:cNvPr>
          <p:cNvGrpSpPr/>
          <p:nvPr/>
        </p:nvGrpSpPr>
        <p:grpSpPr>
          <a:xfrm>
            <a:off x="4396205" y="1835347"/>
            <a:ext cx="870751" cy="307777"/>
            <a:chOff x="1881605" y="482797"/>
            <a:chExt cx="870751" cy="307777"/>
          </a:xfrm>
        </p:grpSpPr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7681357-796C-4F84-A791-B49FDD70FDA3}"/>
                </a:ext>
              </a:extLst>
            </p:cNvPr>
            <p:cNvCxnSpPr>
              <a:cxnSpLocks/>
            </p:cNvCxnSpPr>
            <p:nvPr/>
          </p:nvCxnSpPr>
          <p:spPr>
            <a:xfrm>
              <a:off x="1920904" y="790574"/>
              <a:ext cx="7921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F0420AD-2A87-469D-BE6C-A945CC51F88D}"/>
                </a:ext>
              </a:extLst>
            </p:cNvPr>
            <p:cNvSpPr txBox="1"/>
            <p:nvPr/>
          </p:nvSpPr>
          <p:spPr>
            <a:xfrm>
              <a:off x="1881605" y="482797"/>
              <a:ext cx="8707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p&lt;0.0002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99687C6-565A-4088-BE22-8D6265CC7B9D}"/>
              </a:ext>
            </a:extLst>
          </p:cNvPr>
          <p:cNvGrpSpPr/>
          <p:nvPr/>
        </p:nvGrpSpPr>
        <p:grpSpPr>
          <a:xfrm>
            <a:off x="10330382" y="1835346"/>
            <a:ext cx="870751" cy="307777"/>
            <a:chOff x="1881604" y="482797"/>
            <a:chExt cx="870751" cy="307777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2301ADAB-5FD0-499E-8FBC-74F12C30B039}"/>
                </a:ext>
              </a:extLst>
            </p:cNvPr>
            <p:cNvCxnSpPr>
              <a:cxnSpLocks/>
            </p:cNvCxnSpPr>
            <p:nvPr/>
          </p:nvCxnSpPr>
          <p:spPr>
            <a:xfrm>
              <a:off x="1920904" y="790574"/>
              <a:ext cx="7921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978A4C7-7277-4438-B8B4-CC8907B326D6}"/>
                </a:ext>
              </a:extLst>
            </p:cNvPr>
            <p:cNvSpPr txBox="1"/>
            <p:nvPr/>
          </p:nvSpPr>
          <p:spPr>
            <a:xfrm>
              <a:off x="1881604" y="482797"/>
              <a:ext cx="8707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p=0.0009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F32E14D-5EA9-4B03-8D6C-F62C8FA6DE8B}"/>
              </a:ext>
            </a:extLst>
          </p:cNvPr>
          <p:cNvGrpSpPr/>
          <p:nvPr/>
        </p:nvGrpSpPr>
        <p:grpSpPr>
          <a:xfrm>
            <a:off x="7740157" y="2976061"/>
            <a:ext cx="792148" cy="307777"/>
            <a:chOff x="1920904" y="482797"/>
            <a:chExt cx="792148" cy="307777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CD529C91-B3D9-4EB0-889E-F41EAD773998}"/>
                </a:ext>
              </a:extLst>
            </p:cNvPr>
            <p:cNvCxnSpPr>
              <a:cxnSpLocks/>
            </p:cNvCxnSpPr>
            <p:nvPr/>
          </p:nvCxnSpPr>
          <p:spPr>
            <a:xfrm>
              <a:off x="1920904" y="790574"/>
              <a:ext cx="7921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307C089-74B4-4689-8107-A9A4D9CB61C9}"/>
                </a:ext>
              </a:extLst>
            </p:cNvPr>
            <p:cNvSpPr txBox="1"/>
            <p:nvPr/>
          </p:nvSpPr>
          <p:spPr>
            <a:xfrm>
              <a:off x="2142091" y="482797"/>
              <a:ext cx="3497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s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886D629-479B-4F78-A99C-7C7C31E9E546}"/>
              </a:ext>
            </a:extLst>
          </p:cNvPr>
          <p:cNvGrpSpPr/>
          <p:nvPr/>
        </p:nvGrpSpPr>
        <p:grpSpPr>
          <a:xfrm>
            <a:off x="2059304" y="3428999"/>
            <a:ext cx="792148" cy="307777"/>
            <a:chOff x="1920904" y="482797"/>
            <a:chExt cx="792148" cy="307777"/>
          </a:xfrm>
        </p:grpSpPr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249092C9-9AC2-4A09-AA26-B1F3B9DDD78E}"/>
                </a:ext>
              </a:extLst>
            </p:cNvPr>
            <p:cNvCxnSpPr>
              <a:cxnSpLocks/>
            </p:cNvCxnSpPr>
            <p:nvPr/>
          </p:nvCxnSpPr>
          <p:spPr>
            <a:xfrm>
              <a:off x="1920904" y="790574"/>
              <a:ext cx="7921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F113E7F-8C57-442E-8245-875E390B27E6}"/>
                </a:ext>
              </a:extLst>
            </p:cNvPr>
            <p:cNvSpPr txBox="1"/>
            <p:nvPr/>
          </p:nvSpPr>
          <p:spPr>
            <a:xfrm>
              <a:off x="2142091" y="482797"/>
              <a:ext cx="3497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s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B908D24-12BE-41BB-9108-E21D3DE3FCCD}"/>
              </a:ext>
            </a:extLst>
          </p:cNvPr>
          <p:cNvSpPr txBox="1"/>
          <p:nvPr/>
        </p:nvSpPr>
        <p:spPr>
          <a:xfrm>
            <a:off x="1371599" y="13222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C63A87E-018B-4CCF-B0DC-3E8F9002B794}"/>
              </a:ext>
            </a:extLst>
          </p:cNvPr>
          <p:cNvSpPr txBox="1"/>
          <p:nvPr/>
        </p:nvSpPr>
        <p:spPr>
          <a:xfrm>
            <a:off x="6582238" y="13222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673CE738-8624-4CA0-93D1-AE8AF8B92F7F}"/>
              </a:ext>
            </a:extLst>
          </p:cNvPr>
          <p:cNvGrpSpPr/>
          <p:nvPr/>
        </p:nvGrpSpPr>
        <p:grpSpPr>
          <a:xfrm>
            <a:off x="3755799" y="5733311"/>
            <a:ext cx="4941130" cy="276999"/>
            <a:chOff x="4280593" y="5974709"/>
            <a:chExt cx="4941130" cy="276999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307CABD2-F699-4147-AF18-AD3BEB078E49}"/>
                </a:ext>
              </a:extLst>
            </p:cNvPr>
            <p:cNvSpPr/>
            <p:nvPr/>
          </p:nvSpPr>
          <p:spPr>
            <a:xfrm>
              <a:off x="4280593" y="6032257"/>
              <a:ext cx="384048" cy="161902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41995FE-0F81-4DB2-A263-EAADDE3CDC1D}"/>
                </a:ext>
              </a:extLst>
            </p:cNvPr>
            <p:cNvSpPr txBox="1"/>
            <p:nvPr/>
          </p:nvSpPr>
          <p:spPr>
            <a:xfrm>
              <a:off x="4780710" y="5974709"/>
              <a:ext cx="12025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Mock treatment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12D64A62-B0D5-406D-805C-4B2F5DFBCC43}"/>
                </a:ext>
              </a:extLst>
            </p:cNvPr>
            <p:cNvSpPr/>
            <p:nvPr/>
          </p:nvSpPr>
          <p:spPr>
            <a:xfrm>
              <a:off x="7029426" y="6032257"/>
              <a:ext cx="384048" cy="161902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D3827D3-D65C-4433-9CB1-089F9F0DBC65}"/>
                </a:ext>
              </a:extLst>
            </p:cNvPr>
            <p:cNvSpPr txBox="1"/>
            <p:nvPr/>
          </p:nvSpPr>
          <p:spPr>
            <a:xfrm>
              <a:off x="7524463" y="5974709"/>
              <a:ext cx="16972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50 micromolar paraqua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06074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</TotalTime>
  <Words>49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11</cp:revision>
  <dcterms:created xsi:type="dcterms:W3CDTF">2019-02-26T20:16:22Z</dcterms:created>
  <dcterms:modified xsi:type="dcterms:W3CDTF">2019-04-09T17:59:16Z</dcterms:modified>
</cp:coreProperties>
</file>